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36" d="100"/>
          <a:sy n="36" d="100"/>
        </p:scale>
        <p:origin x="2808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130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8720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9773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216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198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8835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4178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8185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822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0371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5889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0BE14A-9611-4B86-BB64-E64BD2253CE8}" type="datetimeFigureOut">
              <a:rPr lang="ko-KR" altLang="en-US" smtClean="0"/>
              <a:t>2021-06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716DB-ED14-4913-91FA-4502812266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7060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6661973"/>
            <a:ext cx="6408712" cy="890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The expression of the OXSR1 gene in various cells by smoking (A) and glucocorticoid (B) according to cell-based transcriptome studies in REALGAR database (https://realgar.org/)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32656" y="16214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 descr="C:\Users\HUNT2.HUNT-PC\Downloads\REALGAR_smoking_forestplot_OXSR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330" y="1806079"/>
            <a:ext cx="6160008" cy="28066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16580" y="442804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 descr="C:\Users\HUNT2.HUNT-PC\Downloads\REALGAR_treatment_forestplot_OXSR1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255" y="4733607"/>
            <a:ext cx="6182084" cy="15079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334058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1" y="6732240"/>
            <a:ext cx="6408711" cy="1144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The expression of the OXSR1 gene in various subtypes of asthma according to cell-based transcriptome studies in REALGAR database (https://realgar.org/).</a:t>
            </a:r>
            <a:endParaRPr lang="ko-KR" alt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 descr="C:\Users\HUNT2.HUNT-PC\Downloads\REALGAR_asthma_forestplot_OXSR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764" y="1619672"/>
            <a:ext cx="6308588" cy="48245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65235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3</TotalTime>
  <Words>67</Words>
  <Application>Microsoft Office PowerPoint</Application>
  <PresentationFormat>화면 슬라이드 쇼(4:3)</PresentationFormat>
  <Paragraphs>5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UNT2</dc:creator>
  <cp:lastModifiedBy>User1907</cp:lastModifiedBy>
  <cp:revision>4</cp:revision>
  <dcterms:created xsi:type="dcterms:W3CDTF">2021-06-23T03:55:04Z</dcterms:created>
  <dcterms:modified xsi:type="dcterms:W3CDTF">2021-06-24T08:19:03Z</dcterms:modified>
</cp:coreProperties>
</file>